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7740650" cy="4679950"/>
  <p:notesSz cx="6858000" cy="9144000"/>
  <p:defaultTextStyle>
    <a:defPPr>
      <a:defRPr lang="en-US"/>
    </a:defPPr>
    <a:lvl1pPr marL="0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1pPr>
    <a:lvl2pPr marL="600055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2pPr>
    <a:lvl3pPr marL="1200110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3pPr>
    <a:lvl4pPr marL="1800162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4pPr>
    <a:lvl5pPr marL="2400220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5pPr>
    <a:lvl6pPr marL="3000275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6pPr>
    <a:lvl7pPr marL="3600330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7pPr>
    <a:lvl8pPr marL="4200383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8pPr>
    <a:lvl9pPr marL="4800438" algn="l" defTabSz="1200110" rtl="0" eaLnBrk="1" latinLnBrk="0" hangingPunct="1">
      <a:defRPr sz="235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75" userDrawn="1">
          <p15:clr>
            <a:srgbClr val="A4A3A4"/>
          </p15:clr>
        </p15:guide>
        <p15:guide id="2" pos="24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86"/>
    <p:restoredTop sz="94626"/>
  </p:normalViewPr>
  <p:slideViewPr>
    <p:cSldViewPr>
      <p:cViewPr varScale="1">
        <p:scale>
          <a:sx n="177" d="100"/>
          <a:sy n="177" d="100"/>
        </p:scale>
        <p:origin x="1224" y="176"/>
      </p:cViewPr>
      <p:guideLst>
        <p:guide orient="horz" pos="1475"/>
        <p:guide pos="24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u Wei-Xin" userId="355868643b3debea" providerId="LiveId" clId="{083D775E-9C75-4571-981B-EB084AD43864}"/>
    <pc:docChg chg="undo custSel modSld">
      <pc:chgData name="Liu Wei-Xin" userId="355868643b3debea" providerId="LiveId" clId="{083D775E-9C75-4571-981B-EB084AD43864}" dt="2021-10-21T11:19:28.826" v="10" actId="6549"/>
      <pc:docMkLst>
        <pc:docMk/>
      </pc:docMkLst>
      <pc:sldChg chg="modSp mod">
        <pc:chgData name="Liu Wei-Xin" userId="355868643b3debea" providerId="LiveId" clId="{083D775E-9C75-4571-981B-EB084AD43864}" dt="2021-10-21T11:19:28.826" v="10" actId="6549"/>
        <pc:sldMkLst>
          <pc:docMk/>
          <pc:sldMk cId="594491241" sldId="257"/>
        </pc:sldMkLst>
        <pc:spChg chg="mod">
          <ac:chgData name="Liu Wei-Xin" userId="355868643b3debea" providerId="LiveId" clId="{083D775E-9C75-4571-981B-EB084AD43864}" dt="2021-10-21T11:19:28.826" v="10" actId="6549"/>
          <ac:spMkLst>
            <pc:docMk/>
            <pc:sldMk cId="594491241" sldId="257"/>
            <ac:spMk id="77" creationId="{C99BA6FA-2FF5-4111-B0FA-F46C67FF569B}"/>
          </ac:spMkLst>
        </pc:spChg>
      </pc:sldChg>
    </pc:docChg>
  </pc:docChgLst>
  <pc:docChgLst>
    <pc:chgData name="Liu Wei-Xin" userId="355868643b3debea" providerId="LiveId" clId="{7B7A7A42-1693-4D20-9772-BE4BD208C152}"/>
    <pc:docChg chg="undo custSel modSld modMainMaster modNotesMaster">
      <pc:chgData name="Liu Wei-Xin" userId="355868643b3debea" providerId="LiveId" clId="{7B7A7A42-1693-4D20-9772-BE4BD208C152}" dt="2021-12-16T09:01:32.056" v="33" actId="20577"/>
      <pc:docMkLst>
        <pc:docMk/>
      </pc:docMkLst>
      <pc:sldChg chg="addSp delSp modSp mod modNotes">
        <pc:chgData name="Liu Wei-Xin" userId="355868643b3debea" providerId="LiveId" clId="{7B7A7A42-1693-4D20-9772-BE4BD208C152}" dt="2021-12-16T09:01:32.056" v="33" actId="20577"/>
        <pc:sldMkLst>
          <pc:docMk/>
          <pc:sldMk cId="594491241" sldId="257"/>
        </pc:sldMkLst>
        <pc:spChg chg="add mod">
          <ac:chgData name="Liu Wei-Xin" userId="355868643b3debea" providerId="LiveId" clId="{7B7A7A42-1693-4D20-9772-BE4BD208C152}" dt="2021-12-16T09:01:16.590" v="26" actId="1076"/>
          <ac:spMkLst>
            <pc:docMk/>
            <pc:sldMk cId="594491241" sldId="257"/>
            <ac:spMk id="3" creationId="{1B9FAE6C-14BB-44C1-9D1F-5418F1FB1EF1}"/>
          </ac:spMkLst>
        </pc:spChg>
        <pc:spChg chg="add mod">
          <ac:chgData name="Liu Wei-Xin" userId="355868643b3debea" providerId="LiveId" clId="{7B7A7A42-1693-4D20-9772-BE4BD208C152}" dt="2021-12-16T09:01:32.056" v="33" actId="20577"/>
          <ac:spMkLst>
            <pc:docMk/>
            <pc:sldMk cId="594491241" sldId="257"/>
            <ac:spMk id="20" creationId="{411C0922-88D3-499A-A19A-92F708631C2F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63" creationId="{C5A8F567-4B49-4EF6-9764-A22B2A3F38E9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65" creationId="{B59F5BA0-391B-4512-B8EF-E13C3B144224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66" creationId="{92328AF3-0EEA-44DC-8879-BF3928DDC5F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67" creationId="{11DF9CD6-9C72-46ED-B7A2-D1E1B53AD81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68" creationId="{31F047AB-5125-4579-BD1D-C8BBD5ED52C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70" creationId="{A818B79A-A14E-4A04-8C44-0F9CFAB0592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72" creationId="{66CAA334-F386-4A0E-BCEB-DE3D7FCE5C3A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73" creationId="{1C9F95FA-46D8-445B-AEAC-DC1E254F971A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74" creationId="{74F2AC7A-03E9-4C7A-8B53-BC1E244593C7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k cId="594491241" sldId="257"/>
            <ac:spMk id="75" creationId="{84062500-EB3F-442E-A851-96369D0CB271}"/>
          </ac:spMkLst>
        </pc:spChg>
        <pc:spChg chg="del">
          <ac:chgData name="Liu Wei-Xin" userId="355868643b3debea" providerId="LiveId" clId="{7B7A7A42-1693-4D20-9772-BE4BD208C152}" dt="2021-12-16T07:23:41.986" v="0" actId="478"/>
          <ac:spMkLst>
            <pc:docMk/>
            <pc:sldMk cId="594491241" sldId="257"/>
            <ac:spMk id="77" creationId="{C99BA6FA-2FF5-4111-B0FA-F46C67FF569B}"/>
          </ac:spMkLst>
        </pc:spChg>
        <pc:grpChg chg="add mod">
          <ac:chgData name="Liu Wei-Xin" userId="355868643b3debea" providerId="LiveId" clId="{7B7A7A42-1693-4D20-9772-BE4BD208C152}" dt="2021-12-16T07:24:15.448" v="7" actId="1076"/>
          <ac:grpSpMkLst>
            <pc:docMk/>
            <pc:sldMk cId="594491241" sldId="257"/>
            <ac:grpSpMk id="2" creationId="{0031A5F7-8763-40AE-858A-38E1F4C03B81}"/>
          </ac:grpSpMkLst>
        </pc:grpChg>
        <pc:picChg chg="mod modCrop">
          <ac:chgData name="Liu Wei-Xin" userId="355868643b3debea" providerId="LiveId" clId="{7B7A7A42-1693-4D20-9772-BE4BD208C152}" dt="2021-12-16T09:00:55.471" v="8" actId="732"/>
          <ac:picMkLst>
            <pc:docMk/>
            <pc:sldMk cId="594491241" sldId="257"/>
            <ac:picMk id="61" creationId="{3A0AA4BE-31B7-4C51-A81D-27297745EF2D}"/>
          </ac:picMkLst>
        </pc:picChg>
        <pc:picChg chg="mod modCrop">
          <ac:chgData name="Liu Wei-Xin" userId="355868643b3debea" providerId="LiveId" clId="{7B7A7A42-1693-4D20-9772-BE4BD208C152}" dt="2021-12-16T09:01:26.294" v="27" actId="732"/>
          <ac:picMkLst>
            <pc:docMk/>
            <pc:sldMk cId="594491241" sldId="257"/>
            <ac:picMk id="62" creationId="{BC6C4EA8-8D3C-4751-BABC-5EC1BC4B0DD1}"/>
          </ac:picMkLst>
        </pc:picChg>
        <pc:cxnChg chg="mod">
          <ac:chgData name="Liu Wei-Xin" userId="355868643b3debea" providerId="LiveId" clId="{7B7A7A42-1693-4D20-9772-BE4BD208C152}" dt="2021-12-16T07:24:07.369" v="6"/>
          <ac:cxnSpMkLst>
            <pc:docMk/>
            <pc:sldMk cId="594491241" sldId="257"/>
            <ac:cxnSpMk id="64" creationId="{B639D47D-C820-4DB8-9B27-0375473A1568}"/>
          </ac:cxnSpMkLst>
        </pc:cxnChg>
        <pc:cxnChg chg="mod">
          <ac:chgData name="Liu Wei-Xin" userId="355868643b3debea" providerId="LiveId" clId="{7B7A7A42-1693-4D20-9772-BE4BD208C152}" dt="2021-12-16T07:24:07.369" v="6"/>
          <ac:cxnSpMkLst>
            <pc:docMk/>
            <pc:sldMk cId="594491241" sldId="257"/>
            <ac:cxnSpMk id="69" creationId="{B9A8D9E0-BF74-4023-B0BF-8B2499012896}"/>
          </ac:cxnSpMkLst>
        </pc:cxnChg>
        <pc:cxnChg chg="mod">
          <ac:chgData name="Liu Wei-Xin" userId="355868643b3debea" providerId="LiveId" clId="{7B7A7A42-1693-4D20-9772-BE4BD208C152}" dt="2021-12-16T07:24:07.369" v="6"/>
          <ac:cxnSpMkLst>
            <pc:docMk/>
            <pc:sldMk cId="594491241" sldId="257"/>
            <ac:cxnSpMk id="71" creationId="{EF3A42C2-E24A-4D2F-9805-D8DBAEAC51C5}"/>
          </ac:cxnSpMkLst>
        </pc:cxnChg>
        <pc:cxnChg chg="mod">
          <ac:chgData name="Liu Wei-Xin" userId="355868643b3debea" providerId="LiveId" clId="{7B7A7A42-1693-4D20-9772-BE4BD208C152}" dt="2021-12-16T07:24:07.369" v="6"/>
          <ac:cxnSpMkLst>
            <pc:docMk/>
            <pc:sldMk cId="594491241" sldId="257"/>
            <ac:cxnSpMk id="76" creationId="{BDBE2382-6779-4B5A-9EEF-6FBF3B3C6652}"/>
          </ac:cxnSpMkLst>
        </pc:cxnChg>
      </pc:sldChg>
      <pc:sldMasterChg chg="modSp modSldLayout">
        <pc:chgData name="Liu Wei-Xin" userId="355868643b3debea" providerId="LiveId" clId="{7B7A7A42-1693-4D20-9772-BE4BD208C152}" dt="2021-12-16T07:24:07.369" v="6"/>
        <pc:sldMasterMkLst>
          <pc:docMk/>
          <pc:sldMasterMk cId="4024762935" sldId="2147483648"/>
        </pc:sldMasterMkLst>
        <pc:spChg chg="mod">
          <ac:chgData name="Liu Wei-Xin" userId="355868643b3debea" providerId="LiveId" clId="{7B7A7A42-1693-4D20-9772-BE4BD208C152}" dt="2021-12-16T07:24:07.369" v="6"/>
          <ac:spMkLst>
            <pc:docMk/>
            <pc:sldMasterMk cId="4024762935" sldId="2147483648"/>
            <ac:spMk id="2" creationId="{00000000-0000-0000-0000-00000000000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asterMk cId="4024762935" sldId="2147483648"/>
            <ac:spMk id="3" creationId="{00000000-0000-0000-0000-00000000000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asterMk cId="4024762935" sldId="2147483648"/>
            <ac:spMk id="4" creationId="{00000000-0000-0000-0000-00000000000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asterMk cId="4024762935" sldId="2147483648"/>
            <ac:spMk id="5" creationId="{00000000-0000-0000-0000-000000000000}"/>
          </ac:spMkLst>
        </pc:spChg>
        <pc:spChg chg="mod">
          <ac:chgData name="Liu Wei-Xin" userId="355868643b3debea" providerId="LiveId" clId="{7B7A7A42-1693-4D20-9772-BE4BD208C152}" dt="2021-12-16T07:24:07.369" v="6"/>
          <ac:spMkLst>
            <pc:docMk/>
            <pc:sldMasterMk cId="4024762935" sldId="2147483648"/>
            <ac:spMk id="6" creationId="{00000000-0000-0000-0000-000000000000}"/>
          </ac:spMkLst>
        </pc:sp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2354780366" sldId="2147483649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354780366" sldId="2147483649"/>
              <ac:spMk id="2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354780366" sldId="2147483649"/>
              <ac:spMk id="3" creationId="{00000000-0000-0000-0000-000000000000}"/>
            </ac:spMkLst>
          </pc:spChg>
        </pc:sldLayout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2720809504" sldId="2147483651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720809504" sldId="2147483651"/>
              <ac:spMk id="2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720809504" sldId="2147483651"/>
              <ac:spMk id="3" creationId="{00000000-0000-0000-0000-000000000000}"/>
            </ac:spMkLst>
          </pc:spChg>
        </pc:sldLayout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1050180382" sldId="2147483652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1050180382" sldId="2147483652"/>
              <ac:spMk id="3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1050180382" sldId="2147483652"/>
              <ac:spMk id="4" creationId="{00000000-0000-0000-0000-000000000000}"/>
            </ac:spMkLst>
          </pc:spChg>
        </pc:sldLayout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1414771998" sldId="2147483653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1414771998" sldId="2147483653"/>
              <ac:spMk id="3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1414771998" sldId="2147483653"/>
              <ac:spMk id="4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1414771998" sldId="2147483653"/>
              <ac:spMk id="5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1414771998" sldId="2147483653"/>
              <ac:spMk id="6" creationId="{00000000-0000-0000-0000-000000000000}"/>
            </ac:spMkLst>
          </pc:spChg>
        </pc:sldLayout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3559115127" sldId="2147483656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3559115127" sldId="2147483656"/>
              <ac:spMk id="2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3559115127" sldId="2147483656"/>
              <ac:spMk id="3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3559115127" sldId="2147483656"/>
              <ac:spMk id="4" creationId="{00000000-0000-0000-0000-000000000000}"/>
            </ac:spMkLst>
          </pc:spChg>
        </pc:sldLayout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2438420599" sldId="2147483657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438420599" sldId="2147483657"/>
              <ac:spMk id="2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438420599" sldId="2147483657"/>
              <ac:spMk id="3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2438420599" sldId="2147483657"/>
              <ac:spMk id="4" creationId="{00000000-0000-0000-0000-000000000000}"/>
            </ac:spMkLst>
          </pc:spChg>
        </pc:sldLayoutChg>
        <pc:sldLayoutChg chg="modSp">
          <pc:chgData name="Liu Wei-Xin" userId="355868643b3debea" providerId="LiveId" clId="{7B7A7A42-1693-4D20-9772-BE4BD208C152}" dt="2021-12-16T07:24:07.369" v="6"/>
          <pc:sldLayoutMkLst>
            <pc:docMk/>
            <pc:sldMasterMk cId="4024762935" sldId="2147483648"/>
            <pc:sldLayoutMk cId="3750249237" sldId="2147483659"/>
          </pc:sldLayoutMkLst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3750249237" sldId="2147483659"/>
              <ac:spMk id="2" creationId="{00000000-0000-0000-0000-000000000000}"/>
            </ac:spMkLst>
          </pc:spChg>
          <pc:spChg chg="mod">
            <ac:chgData name="Liu Wei-Xin" userId="355868643b3debea" providerId="LiveId" clId="{7B7A7A42-1693-4D20-9772-BE4BD208C152}" dt="2021-12-16T07:24:07.369" v="6"/>
            <ac:spMkLst>
              <pc:docMk/>
              <pc:sldMasterMk cId="4024762935" sldId="2147483648"/>
              <pc:sldLayoutMk cId="3750249237" sldId="2147483659"/>
              <ac:spMk id="3" creationId="{00000000-0000-0000-0000-000000000000}"/>
            </ac:spMkLst>
          </pc:spChg>
        </pc:sldLayoutChg>
      </pc:sldMasterChg>
    </pc:docChg>
  </pc:docChgLst>
  <pc:docChgLst>
    <pc:chgData name="Liu Wei-Xin" userId="355868643b3debea" providerId="LiveId" clId="{83625E81-772F-DF45-B013-56F4DB21A5CF}"/>
    <pc:docChg chg="modSld">
      <pc:chgData name="Liu Wei-Xin" userId="355868643b3debea" providerId="LiveId" clId="{83625E81-772F-DF45-B013-56F4DB21A5CF}" dt="2022-03-02T13:29:50.881" v="24" actId="20577"/>
      <pc:docMkLst>
        <pc:docMk/>
      </pc:docMkLst>
      <pc:sldChg chg="modSp mod">
        <pc:chgData name="Liu Wei-Xin" userId="355868643b3debea" providerId="LiveId" clId="{83625E81-772F-DF45-B013-56F4DB21A5CF}" dt="2022-03-02T13:29:50.881" v="24" actId="20577"/>
        <pc:sldMkLst>
          <pc:docMk/>
          <pc:sldMk cId="594491241" sldId="257"/>
        </pc:sldMkLst>
        <pc:spChg chg="mod">
          <ac:chgData name="Liu Wei-Xin" userId="355868643b3debea" providerId="LiveId" clId="{83625E81-772F-DF45-B013-56F4DB21A5CF}" dt="2022-03-02T13:29:37.405" v="5" actId="20577"/>
          <ac:spMkLst>
            <pc:docMk/>
            <pc:sldMk cId="594491241" sldId="257"/>
            <ac:spMk id="65" creationId="{B59F5BA0-391B-4512-B8EF-E13C3B144224}"/>
          </ac:spMkLst>
        </pc:spChg>
        <pc:spChg chg="mod">
          <ac:chgData name="Liu Wei-Xin" userId="355868643b3debea" providerId="LiveId" clId="{83625E81-772F-DF45-B013-56F4DB21A5CF}" dt="2022-03-02T13:29:39.802" v="8" actId="20577"/>
          <ac:spMkLst>
            <pc:docMk/>
            <pc:sldMk cId="594491241" sldId="257"/>
            <ac:spMk id="66" creationId="{92328AF3-0EEA-44DC-8879-BF3928DDC5F0}"/>
          </ac:spMkLst>
        </pc:spChg>
        <pc:spChg chg="mod">
          <ac:chgData name="Liu Wei-Xin" userId="355868643b3debea" providerId="LiveId" clId="{83625E81-772F-DF45-B013-56F4DB21A5CF}" dt="2022-03-02T13:29:43.072" v="15" actId="20577"/>
          <ac:spMkLst>
            <pc:docMk/>
            <pc:sldMk cId="594491241" sldId="257"/>
            <ac:spMk id="67" creationId="{11DF9CD6-9C72-46ED-B7A2-D1E1B53AD810}"/>
          </ac:spMkLst>
        </pc:spChg>
        <pc:spChg chg="mod">
          <ac:chgData name="Liu Wei-Xin" userId="355868643b3debea" providerId="LiveId" clId="{83625E81-772F-DF45-B013-56F4DB21A5CF}" dt="2022-03-02T13:29:46.201" v="18" actId="20577"/>
          <ac:spMkLst>
            <pc:docMk/>
            <pc:sldMk cId="594491241" sldId="257"/>
            <ac:spMk id="72" creationId="{66CAA334-F386-4A0E-BCEB-DE3D7FCE5C3A}"/>
          </ac:spMkLst>
        </pc:spChg>
        <pc:spChg chg="mod">
          <ac:chgData name="Liu Wei-Xin" userId="355868643b3debea" providerId="LiveId" clId="{83625E81-772F-DF45-B013-56F4DB21A5CF}" dt="2022-03-02T13:29:48.389" v="21" actId="20577"/>
          <ac:spMkLst>
            <pc:docMk/>
            <pc:sldMk cId="594491241" sldId="257"/>
            <ac:spMk id="73" creationId="{1C9F95FA-46D8-445B-AEAC-DC1E254F971A}"/>
          </ac:spMkLst>
        </pc:spChg>
        <pc:spChg chg="mod">
          <ac:chgData name="Liu Wei-Xin" userId="355868643b3debea" providerId="LiveId" clId="{83625E81-772F-DF45-B013-56F4DB21A5CF}" dt="2022-03-02T13:29:50.881" v="24" actId="20577"/>
          <ac:spMkLst>
            <pc:docMk/>
            <pc:sldMk cId="594491241" sldId="257"/>
            <ac:spMk id="74" creationId="{74F2AC7A-03E9-4C7A-8B53-BC1E244593C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F7E645-F4C3-4B69-9342-CFFB532CCD99}" type="datetimeFigureOut">
              <a:rPr lang="en-US" smtClean="0"/>
              <a:t>9/1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593725" y="685800"/>
            <a:ext cx="56705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D9D15-D982-447C-9B58-7E2F227BC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545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1pPr>
    <a:lvl2pPr marL="600055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2pPr>
    <a:lvl3pPr marL="1200110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3pPr>
    <a:lvl4pPr marL="1800162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4pPr>
    <a:lvl5pPr marL="2400220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5pPr>
    <a:lvl6pPr marL="3000275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6pPr>
    <a:lvl7pPr marL="3600330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7pPr>
    <a:lvl8pPr marL="4200383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8pPr>
    <a:lvl9pPr marL="4800438" algn="l" defTabSz="1200110" rtl="0" eaLnBrk="1" latinLnBrk="0" hangingPunct="1">
      <a:defRPr sz="142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593725" y="685800"/>
            <a:ext cx="56705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6C5DB1-74F7-4B65-8E9D-75E9BDA9AC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035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0549" y="1453827"/>
            <a:ext cx="6579552" cy="100315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1099" y="2651973"/>
            <a:ext cx="5418455" cy="11959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88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7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65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5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4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30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1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06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780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003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11977" y="187427"/>
            <a:ext cx="1741647" cy="39931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7033" y="187427"/>
            <a:ext cx="5095928" cy="39931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249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371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1458" y="3007307"/>
            <a:ext cx="6579552" cy="929490"/>
          </a:xfrm>
        </p:spPr>
        <p:txBody>
          <a:bodyPr anchor="t"/>
          <a:lstStyle>
            <a:lvl1pPr algn="l">
              <a:defRPr sz="4475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1458" y="1983567"/>
            <a:ext cx="6579552" cy="1023738"/>
          </a:xfrm>
        </p:spPr>
        <p:txBody>
          <a:bodyPr anchor="b"/>
          <a:lstStyle>
            <a:lvl1pPr marL="0" indent="0">
              <a:buNone/>
              <a:defRPr sz="2358">
                <a:solidFill>
                  <a:schemeClr val="tx1">
                    <a:tint val="75000"/>
                  </a:schemeClr>
                </a:solidFill>
              </a:defRPr>
            </a:lvl1pPr>
            <a:lvl2pPr marL="508837" indent="0">
              <a:buNone/>
              <a:defRPr sz="1996">
                <a:solidFill>
                  <a:schemeClr val="tx1">
                    <a:tint val="75000"/>
                  </a:schemeClr>
                </a:solidFill>
              </a:defRPr>
            </a:lvl2pPr>
            <a:lvl3pPr marL="1017675" indent="0">
              <a:buNone/>
              <a:defRPr sz="1875">
                <a:solidFill>
                  <a:schemeClr val="tx1">
                    <a:tint val="75000"/>
                  </a:schemeClr>
                </a:solidFill>
              </a:defRPr>
            </a:lvl3pPr>
            <a:lvl4pPr marL="1526510" indent="0">
              <a:buNone/>
              <a:defRPr sz="1391">
                <a:solidFill>
                  <a:schemeClr val="tx1">
                    <a:tint val="75000"/>
                  </a:schemeClr>
                </a:solidFill>
              </a:defRPr>
            </a:lvl4pPr>
            <a:lvl5pPr marL="2035350" indent="0">
              <a:buNone/>
              <a:defRPr sz="1391">
                <a:solidFill>
                  <a:schemeClr val="tx1">
                    <a:tint val="75000"/>
                  </a:schemeClr>
                </a:solidFill>
              </a:defRPr>
            </a:lvl5pPr>
            <a:lvl6pPr marL="2544189" indent="0">
              <a:buNone/>
              <a:defRPr sz="1391">
                <a:solidFill>
                  <a:schemeClr val="tx1">
                    <a:tint val="75000"/>
                  </a:schemeClr>
                </a:solidFill>
              </a:defRPr>
            </a:lvl6pPr>
            <a:lvl7pPr marL="3053025" indent="0">
              <a:buNone/>
              <a:defRPr sz="1391">
                <a:solidFill>
                  <a:schemeClr val="tx1">
                    <a:tint val="75000"/>
                  </a:schemeClr>
                </a:solidFill>
              </a:defRPr>
            </a:lvl7pPr>
            <a:lvl8pPr marL="3561862" indent="0">
              <a:buNone/>
              <a:defRPr sz="1391">
                <a:solidFill>
                  <a:schemeClr val="tx1">
                    <a:tint val="75000"/>
                  </a:schemeClr>
                </a:solidFill>
              </a:defRPr>
            </a:lvl8pPr>
            <a:lvl9pPr marL="4070699" indent="0">
              <a:buNone/>
              <a:defRPr sz="13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809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7035" y="1091999"/>
            <a:ext cx="3418787" cy="3088552"/>
          </a:xfrm>
        </p:spPr>
        <p:txBody>
          <a:bodyPr/>
          <a:lstStyle>
            <a:lvl1pPr>
              <a:defRPr sz="3084"/>
            </a:lvl1pPr>
            <a:lvl2pPr>
              <a:defRPr sz="2600"/>
            </a:lvl2pPr>
            <a:lvl3pPr>
              <a:defRPr sz="2358"/>
            </a:lvl3pPr>
            <a:lvl4pPr>
              <a:defRPr sz="1996"/>
            </a:lvl4pPr>
            <a:lvl5pPr>
              <a:defRPr sz="1996"/>
            </a:lvl5pPr>
            <a:lvl6pPr>
              <a:defRPr sz="1996"/>
            </a:lvl6pPr>
            <a:lvl7pPr>
              <a:defRPr sz="1996"/>
            </a:lvl7pPr>
            <a:lvl8pPr>
              <a:defRPr sz="1996"/>
            </a:lvl8pPr>
            <a:lvl9pPr>
              <a:defRPr sz="19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836" y="1091999"/>
            <a:ext cx="3418787" cy="3088552"/>
          </a:xfrm>
        </p:spPr>
        <p:txBody>
          <a:bodyPr/>
          <a:lstStyle>
            <a:lvl1pPr>
              <a:defRPr sz="3084"/>
            </a:lvl1pPr>
            <a:lvl2pPr>
              <a:defRPr sz="2600"/>
            </a:lvl2pPr>
            <a:lvl3pPr>
              <a:defRPr sz="2358"/>
            </a:lvl3pPr>
            <a:lvl4pPr>
              <a:defRPr sz="1996"/>
            </a:lvl4pPr>
            <a:lvl5pPr>
              <a:defRPr sz="1996"/>
            </a:lvl5pPr>
            <a:lvl6pPr>
              <a:defRPr sz="1996"/>
            </a:lvl6pPr>
            <a:lvl7pPr>
              <a:defRPr sz="1996"/>
            </a:lvl7pPr>
            <a:lvl8pPr>
              <a:defRPr sz="1996"/>
            </a:lvl8pPr>
            <a:lvl9pPr>
              <a:defRPr sz="19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18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7036" y="1047573"/>
            <a:ext cx="3420134" cy="436580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508837" indent="0">
              <a:buNone/>
              <a:defRPr sz="2358" b="1"/>
            </a:lvl2pPr>
            <a:lvl3pPr marL="1017675" indent="0">
              <a:buNone/>
              <a:defRPr sz="1996" b="1"/>
            </a:lvl3pPr>
            <a:lvl4pPr marL="1526510" indent="0">
              <a:buNone/>
              <a:defRPr sz="1875" b="1"/>
            </a:lvl4pPr>
            <a:lvl5pPr marL="2035350" indent="0">
              <a:buNone/>
              <a:defRPr sz="1875" b="1"/>
            </a:lvl5pPr>
            <a:lvl6pPr marL="2544189" indent="0">
              <a:buNone/>
              <a:defRPr sz="1875" b="1"/>
            </a:lvl6pPr>
            <a:lvl7pPr marL="3053025" indent="0">
              <a:buNone/>
              <a:defRPr sz="1875" b="1"/>
            </a:lvl7pPr>
            <a:lvl8pPr marL="3561862" indent="0">
              <a:buNone/>
              <a:defRPr sz="1875" b="1"/>
            </a:lvl8pPr>
            <a:lvl9pPr marL="4070699" indent="0">
              <a:buNone/>
              <a:defRPr sz="18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7036" y="1484156"/>
            <a:ext cx="3420134" cy="2696390"/>
          </a:xfrm>
        </p:spPr>
        <p:txBody>
          <a:bodyPr/>
          <a:lstStyle>
            <a:lvl1pPr>
              <a:defRPr sz="2600"/>
            </a:lvl1pPr>
            <a:lvl2pPr>
              <a:defRPr sz="2358"/>
            </a:lvl2pPr>
            <a:lvl3pPr>
              <a:defRPr sz="1996"/>
            </a:lvl3pPr>
            <a:lvl4pPr>
              <a:defRPr sz="1875"/>
            </a:lvl4pPr>
            <a:lvl5pPr>
              <a:defRPr sz="1875"/>
            </a:lvl5pPr>
            <a:lvl6pPr>
              <a:defRPr sz="1875"/>
            </a:lvl6pPr>
            <a:lvl7pPr>
              <a:defRPr sz="1875"/>
            </a:lvl7pPr>
            <a:lvl8pPr>
              <a:defRPr sz="1875"/>
            </a:lvl8pPr>
            <a:lvl9pPr>
              <a:defRPr sz="18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2153" y="1047573"/>
            <a:ext cx="3421475" cy="436580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508837" indent="0">
              <a:buNone/>
              <a:defRPr sz="2358" b="1"/>
            </a:lvl2pPr>
            <a:lvl3pPr marL="1017675" indent="0">
              <a:buNone/>
              <a:defRPr sz="1996" b="1"/>
            </a:lvl3pPr>
            <a:lvl4pPr marL="1526510" indent="0">
              <a:buNone/>
              <a:defRPr sz="1875" b="1"/>
            </a:lvl4pPr>
            <a:lvl5pPr marL="2035350" indent="0">
              <a:buNone/>
              <a:defRPr sz="1875" b="1"/>
            </a:lvl5pPr>
            <a:lvl6pPr marL="2544189" indent="0">
              <a:buNone/>
              <a:defRPr sz="1875" b="1"/>
            </a:lvl6pPr>
            <a:lvl7pPr marL="3053025" indent="0">
              <a:buNone/>
              <a:defRPr sz="1875" b="1"/>
            </a:lvl7pPr>
            <a:lvl8pPr marL="3561862" indent="0">
              <a:buNone/>
              <a:defRPr sz="1875" b="1"/>
            </a:lvl8pPr>
            <a:lvl9pPr marL="4070699" indent="0">
              <a:buNone/>
              <a:defRPr sz="18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2153" y="1484156"/>
            <a:ext cx="3421475" cy="2696390"/>
          </a:xfrm>
        </p:spPr>
        <p:txBody>
          <a:bodyPr/>
          <a:lstStyle>
            <a:lvl1pPr>
              <a:defRPr sz="2600"/>
            </a:lvl1pPr>
            <a:lvl2pPr>
              <a:defRPr sz="2358"/>
            </a:lvl2pPr>
            <a:lvl3pPr>
              <a:defRPr sz="1996"/>
            </a:lvl3pPr>
            <a:lvl4pPr>
              <a:defRPr sz="1875"/>
            </a:lvl4pPr>
            <a:lvl5pPr>
              <a:defRPr sz="1875"/>
            </a:lvl5pPr>
            <a:lvl6pPr>
              <a:defRPr sz="1875"/>
            </a:lvl6pPr>
            <a:lvl7pPr>
              <a:defRPr sz="1875"/>
            </a:lvl7pPr>
            <a:lvl8pPr>
              <a:defRPr sz="1875"/>
            </a:lvl8pPr>
            <a:lvl9pPr>
              <a:defRPr sz="18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771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827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671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7046" y="186335"/>
            <a:ext cx="2546621" cy="792992"/>
          </a:xfrm>
        </p:spPr>
        <p:txBody>
          <a:bodyPr anchor="b"/>
          <a:lstStyle>
            <a:lvl1pPr algn="l">
              <a:defRPr sz="235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26387" y="186337"/>
            <a:ext cx="4327239" cy="3994208"/>
          </a:xfrm>
        </p:spPr>
        <p:txBody>
          <a:bodyPr/>
          <a:lstStyle>
            <a:lvl1pPr>
              <a:defRPr sz="3568"/>
            </a:lvl1pPr>
            <a:lvl2pPr>
              <a:defRPr sz="3084"/>
            </a:lvl2pPr>
            <a:lvl3pPr>
              <a:defRPr sz="2600"/>
            </a:lvl3pPr>
            <a:lvl4pPr>
              <a:defRPr sz="2358"/>
            </a:lvl4pPr>
            <a:lvl5pPr>
              <a:defRPr sz="2358"/>
            </a:lvl5pPr>
            <a:lvl6pPr>
              <a:defRPr sz="2358"/>
            </a:lvl6pPr>
            <a:lvl7pPr>
              <a:defRPr sz="2358"/>
            </a:lvl7pPr>
            <a:lvl8pPr>
              <a:defRPr sz="2358"/>
            </a:lvl8pPr>
            <a:lvl9pPr>
              <a:defRPr sz="235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7046" y="979329"/>
            <a:ext cx="2546621" cy="3201217"/>
          </a:xfrm>
        </p:spPr>
        <p:txBody>
          <a:bodyPr/>
          <a:lstStyle>
            <a:lvl1pPr marL="0" indent="0">
              <a:buNone/>
              <a:defRPr sz="1391"/>
            </a:lvl1pPr>
            <a:lvl2pPr marL="508837" indent="0">
              <a:buNone/>
              <a:defRPr sz="1209"/>
            </a:lvl2pPr>
            <a:lvl3pPr marL="1017675" indent="0">
              <a:buNone/>
              <a:defRPr sz="1088"/>
            </a:lvl3pPr>
            <a:lvl4pPr marL="1526510" indent="0">
              <a:buNone/>
              <a:defRPr sz="1088"/>
            </a:lvl4pPr>
            <a:lvl5pPr marL="2035350" indent="0">
              <a:buNone/>
              <a:defRPr sz="1088"/>
            </a:lvl5pPr>
            <a:lvl6pPr marL="2544189" indent="0">
              <a:buNone/>
              <a:defRPr sz="1088"/>
            </a:lvl6pPr>
            <a:lvl7pPr marL="3053025" indent="0">
              <a:buNone/>
              <a:defRPr sz="1088"/>
            </a:lvl7pPr>
            <a:lvl8pPr marL="3561862" indent="0">
              <a:buNone/>
              <a:defRPr sz="1088"/>
            </a:lvl8pPr>
            <a:lvl9pPr marL="4070699" indent="0">
              <a:buNone/>
              <a:defRPr sz="10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115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17224" y="3275965"/>
            <a:ext cx="4644390" cy="386746"/>
          </a:xfrm>
        </p:spPr>
        <p:txBody>
          <a:bodyPr anchor="b"/>
          <a:lstStyle>
            <a:lvl1pPr algn="l">
              <a:defRPr sz="2358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17224" y="418165"/>
            <a:ext cx="4644390" cy="2807970"/>
          </a:xfrm>
        </p:spPr>
        <p:txBody>
          <a:bodyPr/>
          <a:lstStyle>
            <a:lvl1pPr marL="0" indent="0">
              <a:buNone/>
              <a:defRPr sz="3568"/>
            </a:lvl1pPr>
            <a:lvl2pPr marL="508837" indent="0">
              <a:buNone/>
              <a:defRPr sz="3084"/>
            </a:lvl2pPr>
            <a:lvl3pPr marL="1017675" indent="0">
              <a:buNone/>
              <a:defRPr sz="2600"/>
            </a:lvl3pPr>
            <a:lvl4pPr marL="1526510" indent="0">
              <a:buNone/>
              <a:defRPr sz="2358"/>
            </a:lvl4pPr>
            <a:lvl5pPr marL="2035350" indent="0">
              <a:buNone/>
              <a:defRPr sz="2358"/>
            </a:lvl5pPr>
            <a:lvl6pPr marL="2544189" indent="0">
              <a:buNone/>
              <a:defRPr sz="2358"/>
            </a:lvl6pPr>
            <a:lvl7pPr marL="3053025" indent="0">
              <a:buNone/>
              <a:defRPr sz="2358"/>
            </a:lvl7pPr>
            <a:lvl8pPr marL="3561862" indent="0">
              <a:buNone/>
              <a:defRPr sz="2358"/>
            </a:lvl8pPr>
            <a:lvl9pPr marL="4070699" indent="0">
              <a:buNone/>
              <a:defRPr sz="2358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17224" y="3662713"/>
            <a:ext cx="4644390" cy="549246"/>
          </a:xfrm>
        </p:spPr>
        <p:txBody>
          <a:bodyPr/>
          <a:lstStyle>
            <a:lvl1pPr marL="0" indent="0">
              <a:buNone/>
              <a:defRPr sz="1391"/>
            </a:lvl1pPr>
            <a:lvl2pPr marL="508837" indent="0">
              <a:buNone/>
              <a:defRPr sz="1209"/>
            </a:lvl2pPr>
            <a:lvl3pPr marL="1017675" indent="0">
              <a:buNone/>
              <a:defRPr sz="1088"/>
            </a:lvl3pPr>
            <a:lvl4pPr marL="1526510" indent="0">
              <a:buNone/>
              <a:defRPr sz="1088"/>
            </a:lvl4pPr>
            <a:lvl5pPr marL="2035350" indent="0">
              <a:buNone/>
              <a:defRPr sz="1088"/>
            </a:lvl5pPr>
            <a:lvl6pPr marL="2544189" indent="0">
              <a:buNone/>
              <a:defRPr sz="1088"/>
            </a:lvl6pPr>
            <a:lvl7pPr marL="3053025" indent="0">
              <a:buNone/>
              <a:defRPr sz="1088"/>
            </a:lvl7pPr>
            <a:lvl8pPr marL="3561862" indent="0">
              <a:buNone/>
              <a:defRPr sz="1088"/>
            </a:lvl8pPr>
            <a:lvl9pPr marL="4070699" indent="0">
              <a:buNone/>
              <a:defRPr sz="108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420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7033" y="187419"/>
            <a:ext cx="6966586" cy="779990"/>
          </a:xfrm>
          <a:prstGeom prst="rect">
            <a:avLst/>
          </a:prstGeom>
        </p:spPr>
        <p:txBody>
          <a:bodyPr vert="horz" lIns="168288" tIns="84145" rIns="168288" bIns="84145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7033" y="1091999"/>
            <a:ext cx="6966586" cy="3088552"/>
          </a:xfrm>
          <a:prstGeom prst="rect">
            <a:avLst/>
          </a:prstGeom>
        </p:spPr>
        <p:txBody>
          <a:bodyPr vert="horz" lIns="168288" tIns="84145" rIns="168288" bIns="84145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7033" y="4337628"/>
            <a:ext cx="1806152" cy="249164"/>
          </a:xfrm>
          <a:prstGeom prst="rect">
            <a:avLst/>
          </a:prstGeom>
        </p:spPr>
        <p:txBody>
          <a:bodyPr vert="horz" lIns="168288" tIns="84145" rIns="168288" bIns="84145" rtlCol="0" anchor="ctr"/>
          <a:lstStyle>
            <a:lvl1pPr algn="l">
              <a:defRPr sz="1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92D53-90AF-4892-BA73-D85962F90408}" type="datetimeFigureOut">
              <a:rPr lang="en-US" smtClean="0"/>
              <a:t>9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44722" y="4337628"/>
            <a:ext cx="2451206" cy="249164"/>
          </a:xfrm>
          <a:prstGeom prst="rect">
            <a:avLst/>
          </a:prstGeom>
        </p:spPr>
        <p:txBody>
          <a:bodyPr vert="horz" lIns="168288" tIns="84145" rIns="168288" bIns="84145" rtlCol="0" anchor="ctr"/>
          <a:lstStyle>
            <a:lvl1pPr algn="ctr">
              <a:defRPr sz="1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47466" y="4337628"/>
            <a:ext cx="1806152" cy="249164"/>
          </a:xfrm>
          <a:prstGeom prst="rect">
            <a:avLst/>
          </a:prstGeom>
        </p:spPr>
        <p:txBody>
          <a:bodyPr vert="horz" lIns="168288" tIns="84145" rIns="168288" bIns="84145" rtlCol="0" anchor="ctr"/>
          <a:lstStyle>
            <a:lvl1pPr algn="r">
              <a:defRPr sz="1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62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7675" rtl="0" eaLnBrk="1" latinLnBrk="0" hangingPunct="1">
        <a:spcBef>
          <a:spcPct val="0"/>
        </a:spcBef>
        <a:buNone/>
        <a:defRPr sz="48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1629" indent="-381629" algn="l" defTabSz="1017675" rtl="0" eaLnBrk="1" latinLnBrk="0" hangingPunct="1">
        <a:spcBef>
          <a:spcPct val="20000"/>
        </a:spcBef>
        <a:buFont typeface="Arial" panose="020B0604020202020204" pitchFamily="34" charset="0"/>
        <a:buChar char="•"/>
        <a:defRPr sz="3568" kern="1200">
          <a:solidFill>
            <a:schemeClr val="tx1"/>
          </a:solidFill>
          <a:latin typeface="+mn-lt"/>
          <a:ea typeface="+mn-ea"/>
          <a:cs typeface="+mn-cs"/>
        </a:defRPr>
      </a:lvl1pPr>
      <a:lvl2pPr marL="826861" indent="-318023" algn="l" defTabSz="1017675" rtl="0" eaLnBrk="1" latinLnBrk="0" hangingPunct="1">
        <a:spcBef>
          <a:spcPct val="20000"/>
        </a:spcBef>
        <a:buFont typeface="Arial" panose="020B0604020202020204" pitchFamily="34" charset="0"/>
        <a:buChar char="–"/>
        <a:defRPr sz="3084" kern="1200">
          <a:solidFill>
            <a:schemeClr val="tx1"/>
          </a:solidFill>
          <a:latin typeface="+mn-lt"/>
          <a:ea typeface="+mn-ea"/>
          <a:cs typeface="+mn-cs"/>
        </a:defRPr>
      </a:lvl2pPr>
      <a:lvl3pPr marL="1272093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80931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–"/>
        <a:defRPr sz="2358" kern="1200">
          <a:solidFill>
            <a:schemeClr val="tx1"/>
          </a:solidFill>
          <a:latin typeface="+mn-lt"/>
          <a:ea typeface="+mn-ea"/>
          <a:cs typeface="+mn-cs"/>
        </a:defRPr>
      </a:lvl4pPr>
      <a:lvl5pPr marL="2289768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»"/>
        <a:defRPr sz="2358" kern="1200">
          <a:solidFill>
            <a:schemeClr val="tx1"/>
          </a:solidFill>
          <a:latin typeface="+mn-lt"/>
          <a:ea typeface="+mn-ea"/>
          <a:cs typeface="+mn-cs"/>
        </a:defRPr>
      </a:lvl5pPr>
      <a:lvl6pPr marL="2798606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358" kern="1200">
          <a:solidFill>
            <a:schemeClr val="tx1"/>
          </a:solidFill>
          <a:latin typeface="+mn-lt"/>
          <a:ea typeface="+mn-ea"/>
          <a:cs typeface="+mn-cs"/>
        </a:defRPr>
      </a:lvl6pPr>
      <a:lvl7pPr marL="3307443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358" kern="1200">
          <a:solidFill>
            <a:schemeClr val="tx1"/>
          </a:solidFill>
          <a:latin typeface="+mn-lt"/>
          <a:ea typeface="+mn-ea"/>
          <a:cs typeface="+mn-cs"/>
        </a:defRPr>
      </a:lvl7pPr>
      <a:lvl8pPr marL="3816282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358" kern="1200">
          <a:solidFill>
            <a:schemeClr val="tx1"/>
          </a:solidFill>
          <a:latin typeface="+mn-lt"/>
          <a:ea typeface="+mn-ea"/>
          <a:cs typeface="+mn-cs"/>
        </a:defRPr>
      </a:lvl8pPr>
      <a:lvl9pPr marL="4325119" indent="-254418" algn="l" defTabSz="1017675" rtl="0" eaLnBrk="1" latinLnBrk="0" hangingPunct="1">
        <a:spcBef>
          <a:spcPct val="20000"/>
        </a:spcBef>
        <a:buFont typeface="Arial" panose="020B0604020202020204" pitchFamily="34" charset="0"/>
        <a:buChar char="•"/>
        <a:defRPr sz="23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1pPr>
      <a:lvl2pPr marL="508837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2pPr>
      <a:lvl3pPr marL="1017675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3pPr>
      <a:lvl4pPr marL="1526510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4pPr>
      <a:lvl5pPr marL="2035350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5pPr>
      <a:lvl6pPr marL="2544189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6pPr>
      <a:lvl7pPr marL="3053025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7pPr>
      <a:lvl8pPr marL="3561862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8pPr>
      <a:lvl9pPr marL="4070699" algn="l" defTabSz="1017675" rtl="0" eaLnBrk="1" latinLnBrk="0" hangingPunct="1">
        <a:defRPr sz="199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414D8585-8717-F4E7-6F25-B800FE4B84DD}"/>
              </a:ext>
            </a:extLst>
          </p:cNvPr>
          <p:cNvGrpSpPr/>
          <p:nvPr/>
        </p:nvGrpSpPr>
        <p:grpSpPr>
          <a:xfrm>
            <a:off x="288925" y="484664"/>
            <a:ext cx="6858000" cy="4065111"/>
            <a:chOff x="288925" y="484664"/>
            <a:chExt cx="6858000" cy="4065111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031A5F7-8763-40AE-858A-38E1F4C03B81}"/>
                </a:ext>
              </a:extLst>
            </p:cNvPr>
            <p:cNvGrpSpPr/>
            <p:nvPr/>
          </p:nvGrpSpPr>
          <p:grpSpPr>
            <a:xfrm>
              <a:off x="288925" y="968375"/>
              <a:ext cx="6858000" cy="3581400"/>
              <a:chOff x="288925" y="1481137"/>
              <a:chExt cx="6858000" cy="3581400"/>
            </a:xfrm>
          </p:grpSpPr>
          <p:pic>
            <p:nvPicPr>
              <p:cNvPr id="61" name="Picture 60" descr="Chart, box and whisker chart&#10;&#10;Description automatically generated">
                <a:extLst>
                  <a:ext uri="{FF2B5EF4-FFF2-40B4-BE49-F238E27FC236}">
                    <a16:creationId xmlns:a16="http://schemas.microsoft.com/office/drawing/2014/main" id="{3A0AA4BE-31B7-4C51-A81D-27297745EF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864" r="4445" b="20329"/>
              <a:stretch/>
            </p:blipFill>
            <p:spPr>
              <a:xfrm>
                <a:off x="288925" y="1481137"/>
                <a:ext cx="3276601" cy="2895600"/>
              </a:xfrm>
              <a:prstGeom prst="rect">
                <a:avLst/>
              </a:prstGeom>
            </p:spPr>
          </p:pic>
          <p:pic>
            <p:nvPicPr>
              <p:cNvPr id="62" name="Picture 61" descr="Chart, box and whisker chart&#10;&#10;Description automatically generated">
                <a:extLst>
                  <a:ext uri="{FF2B5EF4-FFF2-40B4-BE49-F238E27FC236}">
                    <a16:creationId xmlns:a16="http://schemas.microsoft.com/office/drawing/2014/main" id="{BC6C4EA8-8D3C-4751-BABC-5EC1BC4B0D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89" t="10864" r="4445" b="20329"/>
              <a:stretch/>
            </p:blipFill>
            <p:spPr>
              <a:xfrm>
                <a:off x="4175125" y="1481137"/>
                <a:ext cx="2971800" cy="2895600"/>
              </a:xfrm>
              <a:prstGeom prst="rect">
                <a:avLst/>
              </a:prstGeom>
            </p:spPr>
          </p:pic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C5A8F567-4B49-4EF6-9764-A22B2A3F38E9}"/>
                  </a:ext>
                </a:extLst>
              </p:cNvPr>
              <p:cNvSpPr txBox="1"/>
              <p:nvPr/>
            </p:nvSpPr>
            <p:spPr>
              <a:xfrm>
                <a:off x="1508125" y="4754760"/>
                <a:ext cx="79220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ared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B639D47D-C820-4DB8-9B27-0375473A15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03325" y="4763491"/>
                <a:ext cx="1371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B59F5BA0-391B-4512-B8EF-E13C3B144224}"/>
                  </a:ext>
                </a:extLst>
              </p:cNvPr>
              <p:cNvSpPr txBox="1"/>
              <p:nvPr/>
            </p:nvSpPr>
            <p:spPr>
              <a:xfrm>
                <a:off x="1116833" y="4313694"/>
                <a:ext cx="782587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</a:t>
                </a:r>
              </a:p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epletion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92328AF3-0EEA-44DC-8879-BF3928DDC5F0}"/>
                  </a:ext>
                </a:extLst>
              </p:cNvPr>
              <p:cNvSpPr txBox="1"/>
              <p:nvPr/>
            </p:nvSpPr>
            <p:spPr>
              <a:xfrm>
                <a:off x="1939927" y="4313694"/>
                <a:ext cx="7825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Depletion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1DF9CD6-9C72-46ED-B7A2-D1E1B53AD810}"/>
                  </a:ext>
                </a:extLst>
              </p:cNvPr>
              <p:cNvSpPr txBox="1"/>
              <p:nvPr/>
            </p:nvSpPr>
            <p:spPr>
              <a:xfrm>
                <a:off x="2763019" y="4313694"/>
                <a:ext cx="7825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Depletion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31F047AB-5125-4579-BD1D-C8BBD5ED52C0}"/>
                  </a:ext>
                </a:extLst>
              </p:cNvPr>
              <p:cNvSpPr txBox="1"/>
              <p:nvPr/>
            </p:nvSpPr>
            <p:spPr>
              <a:xfrm>
                <a:off x="2757530" y="4754760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nique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B9A8D9E0-BF74-4023-B0BF-8B249901289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79050" y="4763491"/>
                <a:ext cx="71027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A818B79A-A14E-4A04-8C44-0F9CFAB05920}"/>
                  </a:ext>
                </a:extLst>
              </p:cNvPr>
              <p:cNvSpPr txBox="1"/>
              <p:nvPr/>
            </p:nvSpPr>
            <p:spPr>
              <a:xfrm>
                <a:off x="5106919" y="4754760"/>
                <a:ext cx="79220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ared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EF3A42C2-E24A-4D2F-9805-D8DBAEAC51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02119" y="4763491"/>
                <a:ext cx="1371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66CAA334-F386-4A0E-BCEB-DE3D7FCE5C3A}"/>
                  </a:ext>
                </a:extLst>
              </p:cNvPr>
              <p:cNvSpPr txBox="1"/>
              <p:nvPr/>
            </p:nvSpPr>
            <p:spPr>
              <a:xfrm>
                <a:off x="4715628" y="4313694"/>
                <a:ext cx="782587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</a:t>
                </a:r>
              </a:p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epletion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1C9F95FA-46D8-445B-AEAC-DC1E254F971A}"/>
                  </a:ext>
                </a:extLst>
              </p:cNvPr>
              <p:cNvSpPr txBox="1"/>
              <p:nvPr/>
            </p:nvSpPr>
            <p:spPr>
              <a:xfrm>
                <a:off x="5538721" y="4313694"/>
                <a:ext cx="7825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Depletion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4F2AC7A-03E9-4C7A-8B53-BC1E244593C7}"/>
                  </a:ext>
                </a:extLst>
              </p:cNvPr>
              <p:cNvSpPr txBox="1"/>
              <p:nvPr/>
            </p:nvSpPr>
            <p:spPr>
              <a:xfrm>
                <a:off x="6361814" y="4313694"/>
                <a:ext cx="7825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Depletion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4062500-EB3F-442E-A851-96369D0CB271}"/>
                  </a:ext>
                </a:extLst>
              </p:cNvPr>
              <p:cNvSpPr txBox="1"/>
              <p:nvPr/>
            </p:nvSpPr>
            <p:spPr>
              <a:xfrm>
                <a:off x="6356324" y="4754760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nique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id="{BDBE2382-6779-4B5A-9EEF-6FBF3B3C66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77844" y="4763491"/>
                <a:ext cx="71027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B9FAE6C-14BB-44C1-9D1F-5418F1FB1EF1}"/>
                </a:ext>
              </a:extLst>
            </p:cNvPr>
            <p:cNvSpPr txBox="1"/>
            <p:nvPr/>
          </p:nvSpPr>
          <p:spPr>
            <a:xfrm>
              <a:off x="1381182" y="484664"/>
              <a:ext cx="16594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Human biopsy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11C0922-88D3-499A-A19A-92F708631C2F}"/>
                </a:ext>
              </a:extLst>
            </p:cNvPr>
            <p:cNvSpPr txBox="1"/>
            <p:nvPr/>
          </p:nvSpPr>
          <p:spPr>
            <a:xfrm>
              <a:off x="4731658" y="484664"/>
              <a:ext cx="16081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dirty="0">
                  <a:latin typeface="Arial" panose="020B0604020202020204" pitchFamily="34" charset="0"/>
                  <a:cs typeface="Arial" panose="020B0604020202020204" pitchFamily="34" charset="0"/>
                </a:rPr>
                <a:t>Mouse biopsy</a:t>
              </a:r>
              <a:endParaRPr lang="zh-CN" altLang="en-US" sz="1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6CD72FC-6A93-C251-8180-A859DF46515C}"/>
                </a:ext>
              </a:extLst>
            </p:cNvPr>
            <p:cNvSpPr txBox="1"/>
            <p:nvPr/>
          </p:nvSpPr>
          <p:spPr>
            <a:xfrm>
              <a:off x="1802761" y="961370"/>
              <a:ext cx="84965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&lt; 0.0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563B752-5664-86EB-1209-0EE8B22B098E}"/>
                </a:ext>
              </a:extLst>
            </p:cNvPr>
            <p:cNvSpPr txBox="1"/>
            <p:nvPr/>
          </p:nvSpPr>
          <p:spPr>
            <a:xfrm>
              <a:off x="5483608" y="952727"/>
              <a:ext cx="84965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&lt; 0.05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A9DF61C-04B0-9D78-34E2-E8E0AE5BA74A}"/>
                </a:ext>
              </a:extLst>
            </p:cNvPr>
            <p:cNvSpPr txBox="1"/>
            <p:nvPr/>
          </p:nvSpPr>
          <p:spPr>
            <a:xfrm>
              <a:off x="5840069" y="1290587"/>
              <a:ext cx="84965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&lt; 0.0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2D657C8-FB25-0293-B0E4-11A05D6E553E}"/>
                </a:ext>
              </a:extLst>
            </p:cNvPr>
            <p:cNvSpPr txBox="1"/>
            <p:nvPr/>
          </p:nvSpPr>
          <p:spPr>
            <a:xfrm>
              <a:off x="2259960" y="1300976"/>
              <a:ext cx="84965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tIns="0" bIns="0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&lt; 0.0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94491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9</Words>
  <Application>Microsoft Macintosh PowerPoint</Application>
  <PresentationFormat>Custom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nie</dc:creator>
  <cp:lastModifiedBy>Liu Wei-Xin</cp:lastModifiedBy>
  <cp:revision>10</cp:revision>
  <dcterms:created xsi:type="dcterms:W3CDTF">2021-03-16T01:35:12Z</dcterms:created>
  <dcterms:modified xsi:type="dcterms:W3CDTF">2022-09-15T15:25:06Z</dcterms:modified>
</cp:coreProperties>
</file>